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8A6F14-797D-4094-9DCA-EC2B2FC4D6F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825027-D4E5-4195-96C2-78B4584A7226}" type="slidenum">
              <a:rPr b="0" lang="zh-CN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  <a:ea typeface="宋体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68FB1-C417-475D-8E9B-66F04739B7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9CFF2F-3586-40F0-A47F-E41C054727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2DC1EE-9566-4CB7-AE03-DC82F840DB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0A4DE-C164-48A8-B4DB-917608876B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30C9F-B505-42E0-BE89-2FD1AFAD80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FA3B20-03CF-4FE2-B4D9-860D859167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040EB-0195-4F16-B687-AAE67482D6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69CDEE-254E-4E1D-893E-E9DCDE66E3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CA9E94-4550-4520-BBBC-64EC6E837F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291992-E14F-4F1C-8247-CF79B3AA6D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77D14A-0379-4B3E-8E57-56F64B2343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24CC87-C79B-443E-93B2-2DD8571CF8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DEFBCB-26A4-40A3-B113-27527FB01D5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1" descr=""/>
          <p:cNvPicPr/>
          <p:nvPr/>
        </p:nvPicPr>
        <p:blipFill>
          <a:blip r:embed="rId1"/>
          <a:stretch/>
        </p:blipFill>
        <p:spPr>
          <a:xfrm>
            <a:off x="2133720" y="762120"/>
            <a:ext cx="3962160" cy="306684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12"/>
          <p:cNvSpPr/>
          <p:nvPr/>
        </p:nvSpPr>
        <p:spPr>
          <a:xfrm>
            <a:off x="1828800" y="3890880"/>
            <a:ext cx="495288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Figure 1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Comparison of expression measurements by microarray and Real Time qRT-PCR assays. Fold changes in Log2 value of 8 genes under aerobic/anaerobic conditions between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arc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 mutant and MR-1 are shown. Genes shown are 1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hoxK,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2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so0186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, 3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acn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, 4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hisG,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5,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 pflA,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6,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 torA,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7,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 napA,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8,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 speF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30T21:13:15Z</dcterms:created>
  <dc:creator>Srtc</dc:creator>
  <dc:description/>
  <dc:language>en-US</dc:language>
  <cp:lastModifiedBy>Srtc</cp:lastModifiedBy>
  <dcterms:modified xsi:type="dcterms:W3CDTF">2007-11-30T21:14:30Z</dcterms:modified>
  <cp:revision>2</cp:revision>
  <dc:subject/>
  <dc:title>Slide 1</dc:title>
</cp:coreProperties>
</file>